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8999538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1273" autoAdjust="0"/>
  </p:normalViewPr>
  <p:slideViewPr>
    <p:cSldViewPr snapToGrid="0">
      <p:cViewPr varScale="1">
        <p:scale>
          <a:sx n="93" d="100"/>
          <a:sy n="93" d="100"/>
        </p:scale>
        <p:origin x="212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2A8ACC-800C-411D-A947-8DB322DD5BD6}" type="datetimeFigureOut">
              <a:rPr lang="ko-KR" altLang="en-US" smtClean="0"/>
              <a:t>23-05-0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500188" y="1143000"/>
            <a:ext cx="38576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55FC58-540C-479B-B142-3AE2D6087C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04222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55FC58-540C-479B-B142-3AE2D6087CD7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69765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178222"/>
            <a:ext cx="7649607" cy="2506427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3781306"/>
            <a:ext cx="6749654" cy="1738167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5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7915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5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438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383297"/>
            <a:ext cx="1940525" cy="610108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383297"/>
            <a:ext cx="5709082" cy="610108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5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3249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5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2169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1794831"/>
            <a:ext cx="7762102" cy="2994714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4817876"/>
            <a:ext cx="7762102" cy="1574849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5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8316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1916484"/>
            <a:ext cx="3824804" cy="456789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1916484"/>
            <a:ext cx="3824804" cy="456789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5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6402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383299"/>
            <a:ext cx="7762102" cy="1391534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1764832"/>
            <a:ext cx="3807226" cy="864917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2629749"/>
            <a:ext cx="3807226" cy="386796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1764832"/>
            <a:ext cx="3825976" cy="864917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2629749"/>
            <a:ext cx="3825976" cy="386796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5-0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7347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5-0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41789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5-0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4178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79954"/>
            <a:ext cx="2902585" cy="167984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036570"/>
            <a:ext cx="4556016" cy="5116178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159794"/>
            <a:ext cx="2902585" cy="400128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5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1387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79954"/>
            <a:ext cx="2902585" cy="167984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036570"/>
            <a:ext cx="4556016" cy="5116178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159794"/>
            <a:ext cx="2902585" cy="400128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5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7591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383299"/>
            <a:ext cx="7762102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1916484"/>
            <a:ext cx="7762102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6672698"/>
            <a:ext cx="202489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6A00F3-C7C9-4822-8FEA-C770EFCB85E1}" type="datetimeFigureOut">
              <a:rPr lang="ko-KR" altLang="en-US" smtClean="0"/>
              <a:t>23-05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6672698"/>
            <a:ext cx="3037344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6672698"/>
            <a:ext cx="202489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5336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99952" rtl="0" eaLnBrk="1" latinLnBrk="1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 descr="차트이(가) 표시된 사진&#10;&#10;자동 생성된 설명">
            <a:extLst>
              <a:ext uri="{FF2B5EF4-FFF2-40B4-BE49-F238E27FC236}">
                <a16:creationId xmlns:a16="http://schemas.microsoft.com/office/drawing/2014/main" id="{5128FDE4-C49C-3003-319C-CA1C90D4F16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351"/>
          <a:stretch/>
        </p:blipFill>
        <p:spPr bwMode="auto">
          <a:xfrm>
            <a:off x="934948" y="665913"/>
            <a:ext cx="7153250" cy="5898144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2B06BF4-8BA6-EA6E-3403-93919840A4E6}"/>
              </a:ext>
            </a:extLst>
          </p:cNvPr>
          <p:cNvSpPr txBox="1"/>
          <p:nvPr/>
        </p:nvSpPr>
        <p:spPr>
          <a:xfrm>
            <a:off x="134936" y="81137"/>
            <a:ext cx="875327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Supplemental Digital Content 1. </a:t>
            </a:r>
            <a:r>
              <a:rPr lang="en-US" altLang="ko-KR" sz="1600" b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odel for End-stage Liver disease score </a:t>
            </a:r>
            <a:endParaRPr lang="ko-KR" altLang="en-US" sz="1600" dirty="0"/>
          </a:p>
          <a:p>
            <a:r>
              <a:rPr lang="en-US" altLang="ko-KR" sz="16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 distribution among deceased-donor liver transplantation recipients in South Korea, 2021.</a:t>
            </a:r>
            <a:endParaRPr lang="ko-KR" altLang="ko-KR" sz="1600" kern="100" dirty="0">
              <a:effectLst/>
              <a:latin typeface="Calibri" panose="020F050202020403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F25BFE9-B681-C1BE-A27A-ABB17CCE3961}"/>
              </a:ext>
            </a:extLst>
          </p:cNvPr>
          <p:cNvSpPr txBox="1"/>
          <p:nvPr/>
        </p:nvSpPr>
        <p:spPr>
          <a:xfrm>
            <a:off x="134936" y="6769335"/>
            <a:ext cx="8753273" cy="6104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latinLnBrk="1">
              <a:lnSpc>
                <a:spcPct val="150000"/>
              </a:lnSpc>
              <a:spcAft>
                <a:spcPts val="800"/>
              </a:spcAft>
            </a:pPr>
            <a:r>
              <a:rPr lang="en-US" altLang="ko-KR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MELD, Model for End-stage Liver Disease.</a:t>
            </a:r>
            <a:endParaRPr lang="ko-KR" altLang="ko-KR" sz="11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Arial" panose="020B0604020202020204" pitchFamily="34" charset="0"/>
            </a:endParaRPr>
          </a:p>
          <a:p>
            <a:endParaRPr lang="ko-KR" altLang="ko-KR" sz="1050" kern="100" dirty="0">
              <a:effectLst/>
              <a:latin typeface="Calibri" panose="020F050202020403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ACE8C632-8FAA-0062-92DC-0D02AE043F86}"/>
              </a:ext>
            </a:extLst>
          </p:cNvPr>
          <p:cNvCxnSpPr/>
          <p:nvPr/>
        </p:nvCxnSpPr>
        <p:spPr>
          <a:xfrm>
            <a:off x="134936" y="6769335"/>
            <a:ext cx="849535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318222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1</TotalTime>
  <Words>33</Words>
  <Application>Microsoft Office PowerPoint</Application>
  <PresentationFormat>사용자 지정</PresentationFormat>
  <Paragraphs>4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im Seung Hyuk</dc:creator>
  <cp:lastModifiedBy>Yim Seung Hyuk</cp:lastModifiedBy>
  <cp:revision>1</cp:revision>
  <dcterms:created xsi:type="dcterms:W3CDTF">2023-05-09T01:23:50Z</dcterms:created>
  <dcterms:modified xsi:type="dcterms:W3CDTF">2023-05-09T01:44:59Z</dcterms:modified>
</cp:coreProperties>
</file>